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7008813" cy="92948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162D1935-C1DC-43F5-BAB6-823E391DB0E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BA3DE49-49DA-4D7A-B62E-5A22AD311F3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77259D3B-7A22-474B-B783-432D7F4710F1}"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0E6D64BA-0F06-4A09-9E31-62304E92900B}"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1121C53-E0C3-481B-832F-35D93514840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13952D3-0804-4743-8431-441F5763F50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0A99758-2122-4802-BA6A-6B73C4D2FEC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0E2BCA0-D95F-44DF-9380-5171479C42A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DA5FFD5-57F1-4893-8B09-BCC7B9192C9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FCB608A-2778-40AD-97F9-EF075799894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7ECE806-4873-4955-895C-68B2CCB13F7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71E3FE8-F99A-4ADB-9336-F1011892CD65}"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8192FD5-5390-43CC-A9F1-BAC71ECA91DF}"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1" name="" descr=""/>
          <p:cNvPicPr/>
          <p:nvPr/>
        </p:nvPicPr>
        <p:blipFill>
          <a:blip r:embed="rId1"/>
          <a:srcRect l="991" t="3960" r="4059" b="2214"/>
          <a:stretch/>
        </p:blipFill>
        <p:spPr>
          <a:xfrm>
            <a:off x="458640" y="457200"/>
            <a:ext cx="6399360" cy="4897440"/>
          </a:xfrm>
          <a:prstGeom prst="rect">
            <a:avLst/>
          </a:prstGeom>
          <a:ln w="0">
            <a:noFill/>
          </a:ln>
        </p:spPr>
      </p:pic>
      <p:sp>
        <p:nvSpPr>
          <p:cNvPr id="42" name=""/>
          <p:cNvSpPr/>
          <p:nvPr/>
        </p:nvSpPr>
        <p:spPr>
          <a:xfrm>
            <a:off x="533520" y="5959080"/>
            <a:ext cx="5943600" cy="1585800"/>
          </a:xfrm>
          <a:prstGeom prst="rect">
            <a:avLst/>
          </a:prstGeom>
          <a:noFill/>
          <a:ln w="0">
            <a:noFill/>
          </a:ln>
        </p:spPr>
        <p:style>
          <a:lnRef idx="0"/>
          <a:fillRef idx="0"/>
          <a:effectRef idx="0"/>
          <a:fontRef idx="minor"/>
        </p:style>
        <p:txBody>
          <a:bodyPr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Figure S3.</a:t>
            </a:r>
            <a:r>
              <a:rPr b="0" lang="en-US" sz="1400" spc="-1" strike="noStrike">
                <a:solidFill>
                  <a:srgbClr val="000000"/>
                </a:solidFill>
                <a:latin typeface="Arial"/>
              </a:rPr>
              <a:t> Cluster analysis of expression microarray. Data from expression microarrays were used to perform cluster analysis. The replicates at each time points were technical replicates and were labeled as “Rep1” and “Rep2”. The scale bar is “1-correlation”. Therefore, the shorter the distance, the stronger the correlation. The result showed that data from the treated and the untreated experiments can be grouped into two different clusters.</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37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7-06-19T14:31:36Z</dcterms:created>
  <dc:creator>Huaxia Qin</dc:creator>
  <dc:description/>
  <dc:language>en-US</dc:language>
  <cp:lastModifiedBy>Ramana Davuluri</cp:lastModifiedBy>
  <dcterms:modified xsi:type="dcterms:W3CDTF">2008-12-10T16:03:34Z</dcterms:modified>
  <cp:revision>31</cp:revision>
  <dc:subject/>
  <dc:title>Slide 1</dc:title>
</cp:coreProperties>
</file>